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58" d="100"/>
          <a:sy n="58" d="100"/>
        </p:scale>
        <p:origin x="-91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78E6C-597C-AA46-A2A4-550C40F3158C}" type="datetimeFigureOut">
              <a:rPr lang="en-US" smtClean="0"/>
              <a:t>18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04D5-3EC6-8644-AB52-12377432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269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78E6C-597C-AA46-A2A4-550C40F3158C}" type="datetimeFigureOut">
              <a:rPr lang="en-US" smtClean="0"/>
              <a:t>18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04D5-3EC6-8644-AB52-12377432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413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78E6C-597C-AA46-A2A4-550C40F3158C}" type="datetimeFigureOut">
              <a:rPr lang="en-US" smtClean="0"/>
              <a:t>18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04D5-3EC6-8644-AB52-12377432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477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78E6C-597C-AA46-A2A4-550C40F3158C}" type="datetimeFigureOut">
              <a:rPr lang="en-US" smtClean="0"/>
              <a:t>18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04D5-3EC6-8644-AB52-12377432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338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78E6C-597C-AA46-A2A4-550C40F3158C}" type="datetimeFigureOut">
              <a:rPr lang="en-US" smtClean="0"/>
              <a:t>18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04D5-3EC6-8644-AB52-12377432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3385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78E6C-597C-AA46-A2A4-550C40F3158C}" type="datetimeFigureOut">
              <a:rPr lang="en-US" smtClean="0"/>
              <a:t>18/1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04D5-3EC6-8644-AB52-12377432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290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78E6C-597C-AA46-A2A4-550C40F3158C}" type="datetimeFigureOut">
              <a:rPr lang="en-US" smtClean="0"/>
              <a:t>18/12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04D5-3EC6-8644-AB52-12377432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933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78E6C-597C-AA46-A2A4-550C40F3158C}" type="datetimeFigureOut">
              <a:rPr lang="en-US" smtClean="0"/>
              <a:t>18/12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04D5-3EC6-8644-AB52-12377432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694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78E6C-597C-AA46-A2A4-550C40F3158C}" type="datetimeFigureOut">
              <a:rPr lang="en-US" smtClean="0"/>
              <a:t>18/12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04D5-3EC6-8644-AB52-12377432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494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78E6C-597C-AA46-A2A4-550C40F3158C}" type="datetimeFigureOut">
              <a:rPr lang="en-US" smtClean="0"/>
              <a:t>18/1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04D5-3EC6-8644-AB52-12377432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9388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78E6C-597C-AA46-A2A4-550C40F3158C}" type="datetimeFigureOut">
              <a:rPr lang="en-US" smtClean="0"/>
              <a:t>18/1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04D5-3EC6-8644-AB52-12377432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910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178E6C-597C-AA46-A2A4-550C40F3158C}" type="datetimeFigureOut">
              <a:rPr lang="en-US" smtClean="0"/>
              <a:t>18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D04D5-3EC6-8644-AB52-12377432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205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emf"/><Relationship Id="rId3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8122" y="1421862"/>
            <a:ext cx="3352800" cy="3175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0870" y="1410819"/>
            <a:ext cx="3352800" cy="3175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76087" y="894522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(A)</a:t>
            </a:r>
            <a:endParaRPr lang="en-US" sz="1200" b="1" dirty="0">
              <a:latin typeface="Times New Roman"/>
              <a:cs typeface="Times New Roman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300870" y="894522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(B)</a:t>
            </a:r>
            <a:endParaRPr lang="en-US" sz="1200" b="1" dirty="0">
              <a:latin typeface="Times New Roman"/>
              <a:cs typeface="Times New Roman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0" y="5852874"/>
            <a:ext cx="90322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Supporting Figure 1: </a:t>
            </a:r>
            <a:r>
              <a:rPr lang="en-US" sz="1200" dirty="0" smtClean="0">
                <a:latin typeface="Times New Roman"/>
                <a:cs typeface="Times New Roman"/>
              </a:rPr>
              <a:t>Intra-platelet (IP) PDGF-BB concentrations in recurrent and non-recurrence cases (A) before (PRE OP) and (B) 4 weeks</a:t>
            </a:r>
          </a:p>
          <a:p>
            <a:r>
              <a:rPr lang="en-US" sz="1200" dirty="0" smtClean="0">
                <a:latin typeface="Times New Roman"/>
                <a:cs typeface="Times New Roman"/>
              </a:rPr>
              <a:t>after liver resection (POST OP). IP concentrations are expressed per 10</a:t>
            </a:r>
            <a:r>
              <a:rPr lang="en-US" sz="1200" baseline="30000" dirty="0" smtClean="0">
                <a:latin typeface="Times New Roman"/>
                <a:cs typeface="Times New Roman"/>
              </a:rPr>
              <a:t>6</a:t>
            </a:r>
            <a:r>
              <a:rPr lang="en-US" sz="1200" dirty="0" smtClean="0">
                <a:latin typeface="Times New Roman"/>
                <a:cs typeface="Times New Roman"/>
              </a:rPr>
              <a:t> platelets.</a:t>
            </a:r>
          </a:p>
          <a:p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003601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5839" y="1557131"/>
            <a:ext cx="3317989" cy="313634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38969" y="1546088"/>
            <a:ext cx="3352248" cy="316873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5852874"/>
            <a:ext cx="89050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Supporting Figure 2: </a:t>
            </a:r>
            <a:r>
              <a:rPr lang="en-US" sz="1200" dirty="0" smtClean="0">
                <a:latin typeface="Times New Roman"/>
                <a:cs typeface="Times New Roman"/>
              </a:rPr>
              <a:t>Intra-platelet (IP) P-selectin concentrations in recurrent and non-recurrence cases (A) before (PRE OP) and (B) 4 weeks</a:t>
            </a:r>
          </a:p>
          <a:p>
            <a:r>
              <a:rPr lang="en-US" sz="1200" dirty="0" smtClean="0">
                <a:latin typeface="Times New Roman"/>
                <a:cs typeface="Times New Roman"/>
              </a:rPr>
              <a:t>after liver resection (POST OP). IP concentrations are expressed per 10</a:t>
            </a:r>
            <a:r>
              <a:rPr lang="en-US" sz="1200" baseline="30000" dirty="0" smtClean="0">
                <a:latin typeface="Times New Roman"/>
                <a:cs typeface="Times New Roman"/>
              </a:rPr>
              <a:t>6</a:t>
            </a:r>
            <a:r>
              <a:rPr lang="en-US" sz="1200" dirty="0" smtClean="0">
                <a:latin typeface="Times New Roman"/>
                <a:cs typeface="Times New Roman"/>
              </a:rPr>
              <a:t> platelets.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76087" y="894522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(A)</a:t>
            </a:r>
            <a:endParaRPr 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5338969" y="894522"/>
            <a:ext cx="3668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(B)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2960185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14</Words>
  <Application>Microsoft Macintosh PowerPoint</Application>
  <PresentationFormat>On-screen Show (4:3)</PresentationFormat>
  <Paragraphs>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Cardiovascular And Gastroeneterological Surgery, Kagoshima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bek A</dc:creator>
  <cp:lastModifiedBy>Bibek A</cp:lastModifiedBy>
  <cp:revision>2</cp:revision>
  <dcterms:created xsi:type="dcterms:W3CDTF">2018-12-14T04:08:04Z</dcterms:created>
  <dcterms:modified xsi:type="dcterms:W3CDTF">2018-12-14T06:14:52Z</dcterms:modified>
</cp:coreProperties>
</file>